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14"/>
  </p:handoutMasterIdLst>
  <p:sldIdLst>
    <p:sldId id="256" r:id="rId2"/>
    <p:sldId id="257" r:id="rId3"/>
    <p:sldId id="259" r:id="rId4"/>
    <p:sldId id="261" r:id="rId5"/>
    <p:sldId id="260" r:id="rId6"/>
    <p:sldId id="264" r:id="rId7"/>
    <p:sldId id="265" r:id="rId8"/>
    <p:sldId id="258" r:id="rId9"/>
    <p:sldId id="262" r:id="rId10"/>
    <p:sldId id="266" r:id="rId11"/>
    <p:sldId id="267" r:id="rId12"/>
    <p:sldId id="268" r:id="rId1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 snapToGrid="0">
      <p:cViewPr varScale="1">
        <p:scale>
          <a:sx n="70" d="100"/>
          <a:sy n="70" d="100"/>
        </p:scale>
        <p:origin x="501" y="4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1389"/>
    </p:cViewPr>
  </p:sorterViewPr>
  <p:notesViewPr>
    <p:cSldViewPr snapToGrid="0">
      <p:cViewPr varScale="1">
        <p:scale>
          <a:sx n="56" d="100"/>
          <a:sy n="56" d="100"/>
        </p:scale>
        <p:origin x="2586" y="51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>
            <a:extLst>
              <a:ext uri="{FF2B5EF4-FFF2-40B4-BE49-F238E27FC236}">
                <a16:creationId xmlns:a16="http://schemas.microsoft.com/office/drawing/2014/main" id="{6A6C95B5-B6AC-46FB-7458-9A33EC622406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7890242F-F014-8D16-87A7-7A2FAD8BA9CC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4AE60CD-27DC-4114-B3B6-BDAA8064B4F8}" type="datetimeFigureOut">
              <a:rPr lang="zh-CN" altLang="en-US" smtClean="0"/>
              <a:t>2022/12/1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DE520AE6-6BEE-681B-4C19-997DCD939598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4D42234D-6561-697B-ACC1-5A870516070F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89191E2-0F47-4C9C-9499-E119E4320BB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392538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6CAE6BD-EF67-D1EA-004E-A3176DFE9C2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D1A91B84-5E05-4EF7-B9B9-DB134F64870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59D025A-46A7-6166-56E6-50C7C643FD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B3118-20FC-44CF-985A-4B28F76B6B02}" type="datetimeFigureOut">
              <a:rPr lang="zh-CN" altLang="en-US" smtClean="0"/>
              <a:t>2022/12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D136A66-E8D9-5EA4-88E8-5358ED722F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EFD2E33-40F5-37C0-0DCE-5071FB8563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EFD6C-BA89-48A7-8D60-F84B50E4DF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45698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519D33A-E1F0-38D7-0CC4-A0CA08FEF4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EA1BC75-B8B1-E5B1-5BB0-D45CEEED1A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F866FFA-0DD7-EE11-D20A-5B2237AABE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B3118-20FC-44CF-985A-4B28F76B6B02}" type="datetimeFigureOut">
              <a:rPr lang="zh-CN" altLang="en-US" smtClean="0"/>
              <a:t>2022/12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73B8556-1850-E705-F2CC-1F4450B7BE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51027BB-A43D-2992-DFB8-4BA5A39467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EFD6C-BA89-48A7-8D60-F84B50E4DF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34834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409F1C16-04F7-A095-AE0E-48DBA03A010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38875BC-5DEE-4B5B-E310-83C12FA5589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036EA70-ECAF-7BF3-E637-CC0AA4D631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B3118-20FC-44CF-985A-4B28F76B6B02}" type="datetimeFigureOut">
              <a:rPr lang="zh-CN" altLang="en-US" smtClean="0"/>
              <a:t>2022/12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C4C3BB3-CD5E-8A37-0299-C1E6919AFA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F5AEBCA-700F-1BAF-33BE-72DF7DF7D2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EFD6C-BA89-48A7-8D60-F84B50E4DF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56908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8F70332-E1E2-E6B6-A5A2-550DFA6EEB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163B870-F2A3-4CB8-C504-4A6BAB85660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9B61B13-6A24-D26F-C0AD-F0A78B435F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B3118-20FC-44CF-985A-4B28F76B6B02}" type="datetimeFigureOut">
              <a:rPr lang="zh-CN" altLang="en-US" smtClean="0"/>
              <a:t>2022/12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8B6FC78-6CD8-9618-CEF7-BF9EEE1FDA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10F21E5-77E1-E7EF-35FC-8C41AA2538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EFD6C-BA89-48A7-8D60-F84B50E4DF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49009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E15AE50-D00B-7705-9FDD-5E4E9AF8B9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8C6F96D-2814-7938-1049-97635197F7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C4F9A89-03C1-44A6-DE6E-1153B89179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B3118-20FC-44CF-985A-4B28F76B6B02}" type="datetimeFigureOut">
              <a:rPr lang="zh-CN" altLang="en-US" smtClean="0"/>
              <a:t>2022/12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C9C3333-2441-CCE5-642E-39AFDF6F92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4895B6F-11FF-E419-7E5C-7C3DC291D9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EFD6C-BA89-48A7-8D60-F84B50E4DF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34730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25FD2AC-AF72-93D3-F2E1-4D0F9213F1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4CEFA31-514D-1092-B09A-867C03478E6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13C4843-92C2-4E99-E1B1-21DC7D6B749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4DC4E3B-17D1-4A4F-45B3-81123E3C2B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B3118-20FC-44CF-985A-4B28F76B6B02}" type="datetimeFigureOut">
              <a:rPr lang="zh-CN" altLang="en-US" smtClean="0"/>
              <a:t>2022/12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6A11059-670E-6E3F-D80F-32BFF29153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5A523D9-1D0C-C343-5FCC-74AF08511C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EFD6C-BA89-48A7-8D60-F84B50E4DF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579057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10C4088-6242-A75D-FAA2-3B62349F1F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708535B-8C5E-666C-D9A9-1F1FCA5D37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C8FB779-8687-E104-A361-0A857AAF260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47398CEE-2044-0FB0-72E0-96BBEB8C5DB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E247D7E5-B7E4-9446-3A3A-5D046DB74AD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A4D6A520-AE24-E387-0539-64B06FBC73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B3118-20FC-44CF-985A-4B28F76B6B02}" type="datetimeFigureOut">
              <a:rPr lang="zh-CN" altLang="en-US" smtClean="0"/>
              <a:t>2022/12/1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D52874A1-295A-E977-8A77-EB0B5C743F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5F6CBA3C-0B2A-1951-137C-AF8AEBD6B0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EFD6C-BA89-48A7-8D60-F84B50E4DF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8964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8DB064F-498A-B05D-E1A8-AC7DF90309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9EB3292A-0923-67A7-6C80-966BFD0B90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B3118-20FC-44CF-985A-4B28F76B6B02}" type="datetimeFigureOut">
              <a:rPr lang="zh-CN" altLang="en-US" smtClean="0"/>
              <a:t>2022/12/1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C87D510B-EE04-0788-3F34-45123398EC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49EEF50E-E3A1-5DD6-A793-DEEEC1E489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EFD6C-BA89-48A7-8D60-F84B50E4DF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27583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F7185BAB-752F-520F-8A1D-0EEA5DBE31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B3118-20FC-44CF-985A-4B28F76B6B02}" type="datetimeFigureOut">
              <a:rPr lang="zh-CN" altLang="en-US" smtClean="0"/>
              <a:t>2022/12/1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AFCC4B51-C0FE-1638-9E06-914FF0F79A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4C10572C-0B97-0123-F24D-7007E87B10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EFD6C-BA89-48A7-8D60-F84B50E4DF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18062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5DEDBEE-C3E2-03AF-C02C-0DAA115338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BB2F5A8-EB83-64FD-6DAB-2647C76BA3F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ED4F07A-CFAE-4E7A-945D-66A21535654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DD58A2C-3B65-BEBD-6190-807DE201C3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B3118-20FC-44CF-985A-4B28F76B6B02}" type="datetimeFigureOut">
              <a:rPr lang="zh-CN" altLang="en-US" smtClean="0"/>
              <a:t>2022/12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E105443-CE3D-DFAD-D65C-5C1DFDAE7E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E00FBE1-5A3D-0B5C-6EB1-066FA1FA7A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EFD6C-BA89-48A7-8D60-F84B50E4DF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97872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05B277E-2762-AD03-5AB7-B121AF3DC7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E9A07A07-8604-A336-F17D-C2DDD4E5A14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0049E23-4C85-A940-4A2A-79D8CEE62F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D3991F1-91DD-9838-866F-D066CCBF3A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B3118-20FC-44CF-985A-4B28F76B6B02}" type="datetimeFigureOut">
              <a:rPr lang="zh-CN" altLang="en-US" smtClean="0"/>
              <a:t>2022/12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C44B60C-25CC-1BC9-D90A-A017EE78B7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7AA12E7-F0FE-D4B8-3EC9-09CA782C22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DEFD6C-BA89-48A7-8D60-F84B50E4DF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51919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C4114FCF-9CD1-5284-55E2-3FA7906235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8323BAA-3978-DBF7-3DAD-EE70F86DD6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3614BCA-FF15-3291-001E-6950DF84B59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6B3118-20FC-44CF-985A-4B28F76B6B02}" type="datetimeFigureOut">
              <a:rPr lang="zh-CN" altLang="en-US" smtClean="0"/>
              <a:t>2022/12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8FCEA6A-EC0F-915B-001E-247C1C6DE04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74554A0-CA72-7150-512D-18B0BF931DB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DEFD6C-BA89-48A7-8D60-F84B50E4DF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71531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5322F2E-BE32-9C25-5232-44AFB77A7897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en-US" altLang="zh-CN" sz="4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cropped scans of all blots and gels</a:t>
            </a:r>
            <a:endParaRPr lang="zh-CN" altLang="en-US" sz="4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5637473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FFEFE9CE-FD59-8CF0-C02E-1D1B908B53F0}"/>
              </a:ext>
            </a:extLst>
          </p:cNvPr>
          <p:cNvSpPr txBox="1"/>
          <p:nvPr/>
        </p:nvSpPr>
        <p:spPr>
          <a:xfrm>
            <a:off x="422031" y="154745"/>
            <a:ext cx="15023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4C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038A0A7E-9C68-588D-1648-6BB23C22FF7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73182" y="818707"/>
            <a:ext cx="8270414" cy="55070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9544508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7FD3BF8F-FE1D-584A-4C8A-4CF81CE1DCE3}"/>
              </a:ext>
            </a:extLst>
          </p:cNvPr>
          <p:cNvSpPr txBox="1"/>
          <p:nvPr/>
        </p:nvSpPr>
        <p:spPr>
          <a:xfrm>
            <a:off x="422031" y="154745"/>
            <a:ext cx="15023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4D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CBE00B2F-3C2C-9A14-218A-62D0F4DCA18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39934" y="723311"/>
            <a:ext cx="8220071" cy="55384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9625222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C2051E9-EFF6-65D6-650B-65103E77BD09}"/>
              </a:ext>
            </a:extLst>
          </p:cNvPr>
          <p:cNvSpPr txBox="1"/>
          <p:nvPr/>
        </p:nvSpPr>
        <p:spPr>
          <a:xfrm>
            <a:off x="422031" y="154745"/>
            <a:ext cx="15023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4A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D71AE439-8502-92C8-ED1B-22FAEA22999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61713" y="154745"/>
            <a:ext cx="4267570" cy="64074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434848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B867A6E5-C53A-F445-74E4-A77E6CC51B87}"/>
              </a:ext>
            </a:extLst>
          </p:cNvPr>
          <p:cNvSpPr txBox="1"/>
          <p:nvPr/>
        </p:nvSpPr>
        <p:spPr>
          <a:xfrm>
            <a:off x="422031" y="154745"/>
            <a:ext cx="23843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1A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1F6AE5B6-44DA-91D3-8E5C-FD3928623AA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3317" y="1064420"/>
            <a:ext cx="4866308" cy="3596289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6C4CAAF8-5906-40EC-DC2A-A902BD1A2F3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10380" y="1064420"/>
            <a:ext cx="4438273" cy="38530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515366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文本框 65"/>
          <p:cNvSpPr txBox="1"/>
          <p:nvPr/>
        </p:nvSpPr>
        <p:spPr>
          <a:xfrm>
            <a:off x="422031" y="154745"/>
            <a:ext cx="9566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1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A8F0B4D6-261D-DF02-4A8C-86456868442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5521" y="524077"/>
            <a:ext cx="4804064" cy="5175953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313E93C1-F530-9356-97D0-C875831FC4E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05647" y="536270"/>
            <a:ext cx="4676037" cy="51637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9284745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EBD5C7CD-4EC2-FE4A-13B9-FD08F6E1D935}"/>
              </a:ext>
            </a:extLst>
          </p:cNvPr>
          <p:cNvSpPr txBox="1"/>
          <p:nvPr/>
        </p:nvSpPr>
        <p:spPr>
          <a:xfrm>
            <a:off x="142252" y="72858"/>
            <a:ext cx="9566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2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70CB0108-FB48-92C5-1872-54B40500168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10710" y="620947"/>
            <a:ext cx="9198317" cy="58412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121644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文本框 48"/>
          <p:cNvSpPr txBox="1"/>
          <p:nvPr/>
        </p:nvSpPr>
        <p:spPr>
          <a:xfrm>
            <a:off x="422031" y="154745"/>
            <a:ext cx="9566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2C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0BAE1AE1-89A3-C52A-D603-2270A7E3EB1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3202" y="768110"/>
            <a:ext cx="5090601" cy="4925995"/>
          </a:xfrm>
          <a:prstGeom prst="rect">
            <a:avLst/>
          </a:prstGeom>
        </p:spPr>
      </p:pic>
      <p:pic>
        <p:nvPicPr>
          <p:cNvPr id="32" name="图片 31">
            <a:extLst>
              <a:ext uri="{FF2B5EF4-FFF2-40B4-BE49-F238E27FC236}">
                <a16:creationId xmlns:a16="http://schemas.microsoft.com/office/drawing/2014/main" id="{1FFFF543-6808-8F00-E279-D2BC789700D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000" y="771521"/>
            <a:ext cx="5389331" cy="47370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379949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7" name="图片 76">
            <a:extLst>
              <a:ext uri="{FF2B5EF4-FFF2-40B4-BE49-F238E27FC236}">
                <a16:creationId xmlns:a16="http://schemas.microsoft.com/office/drawing/2014/main" id="{23EC9C5E-4EDF-843D-78DA-E70E9D2583E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42665" y="1615941"/>
            <a:ext cx="10706669" cy="3626117"/>
          </a:xfrm>
          <a:prstGeom prst="rect">
            <a:avLst/>
          </a:prstGeom>
        </p:spPr>
      </p:pic>
      <p:sp>
        <p:nvSpPr>
          <p:cNvPr id="78" name="文本框 77">
            <a:extLst>
              <a:ext uri="{FF2B5EF4-FFF2-40B4-BE49-F238E27FC236}">
                <a16:creationId xmlns:a16="http://schemas.microsoft.com/office/drawing/2014/main" id="{C52DE1DC-55FC-2F53-DBE4-CF616F16677C}"/>
              </a:ext>
            </a:extLst>
          </p:cNvPr>
          <p:cNvSpPr txBox="1"/>
          <p:nvPr/>
        </p:nvSpPr>
        <p:spPr>
          <a:xfrm>
            <a:off x="422031" y="154745"/>
            <a:ext cx="15023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4A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2398080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7F57508C-FD63-76A1-6FCE-F5CC739D4BE0}"/>
              </a:ext>
            </a:extLst>
          </p:cNvPr>
          <p:cNvSpPr txBox="1"/>
          <p:nvPr/>
        </p:nvSpPr>
        <p:spPr>
          <a:xfrm>
            <a:off x="422031" y="154745"/>
            <a:ext cx="15023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4C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B2479F5C-34C3-816A-E3BA-C79DA4A9A27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70005" y="319770"/>
            <a:ext cx="9851990" cy="62184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9556346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A49E5D09-609E-1E75-D877-A45E86B667C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1207" y="1347035"/>
            <a:ext cx="11089585" cy="4163929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29E95698-C298-60CB-3BBD-866F9B14CD31}"/>
              </a:ext>
            </a:extLst>
          </p:cNvPr>
          <p:cNvSpPr txBox="1"/>
          <p:nvPr/>
        </p:nvSpPr>
        <p:spPr>
          <a:xfrm>
            <a:off x="422031" y="154745"/>
            <a:ext cx="15023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4A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2196633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AD5F3F3F-95EB-8B36-1C6B-5ED9C9E42EA6}"/>
              </a:ext>
            </a:extLst>
          </p:cNvPr>
          <p:cNvSpPr txBox="1"/>
          <p:nvPr/>
        </p:nvSpPr>
        <p:spPr>
          <a:xfrm>
            <a:off x="422031" y="154745"/>
            <a:ext cx="15023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4B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522F3495-073F-3C0B-C4C7-B30CEE459B1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4408" y="859314"/>
            <a:ext cx="10509682" cy="47201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421796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3</TotalTime>
  <Words>40</Words>
  <Application>Microsoft Office PowerPoint</Application>
  <PresentationFormat>宽屏</PresentationFormat>
  <Paragraphs>12</Paragraphs>
  <Slides>1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2</vt:i4>
      </vt:variant>
    </vt:vector>
  </HeadingPairs>
  <TitlesOfParts>
    <vt:vector size="17" baseType="lpstr">
      <vt:lpstr>等线</vt:lpstr>
      <vt:lpstr>等线 Light</vt:lpstr>
      <vt:lpstr>Arial</vt:lpstr>
      <vt:lpstr>Times New Roman</vt:lpstr>
      <vt:lpstr>Office 主题​​</vt:lpstr>
      <vt:lpstr>Uncropped scans of all blots and gels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Uncropped scans of all blots and gels</dc:title>
  <dc:creator>lily</dc:creator>
  <cp:lastModifiedBy>lily</cp:lastModifiedBy>
  <cp:revision>2</cp:revision>
  <dcterms:created xsi:type="dcterms:W3CDTF">2022-12-18T13:34:13Z</dcterms:created>
  <dcterms:modified xsi:type="dcterms:W3CDTF">2022-12-18T21:05:13Z</dcterms:modified>
</cp:coreProperties>
</file>